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4ACFD65-DE26-48B2-A4D1-0DD537DA7311}" v="113" dt="2022-01-10T01:36:41.678"/>
    <p1510:client id="{58E1968D-70AC-49E0-B4C2-774E1010BA66}" v="174" dt="2022-01-10T02:09:52.5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>
        <p:scale>
          <a:sx n="120" d="100"/>
          <a:sy n="120" d="100"/>
        </p:scale>
        <p:origin x="1608" y="-3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ndre" userId="2b2fb5af-1a8e-42b9-9a1c-9724d1b34ce9" providerId="ADAL" clId="{58E1968D-70AC-49E0-B4C2-774E1010BA66}"/>
    <pc:docChg chg="custSel modSld">
      <pc:chgData name="Alexandre" userId="2b2fb5af-1a8e-42b9-9a1c-9724d1b34ce9" providerId="ADAL" clId="{58E1968D-70AC-49E0-B4C2-774E1010BA66}" dt="2022-01-10T02:09:45.425" v="650" actId="20577"/>
      <pc:docMkLst>
        <pc:docMk/>
      </pc:docMkLst>
      <pc:sldChg chg="addSp delSp modSp mod">
        <pc:chgData name="Alexandre" userId="2b2fb5af-1a8e-42b9-9a1c-9724d1b34ce9" providerId="ADAL" clId="{58E1968D-70AC-49E0-B4C2-774E1010BA66}" dt="2022-01-10T02:09:45.425" v="650" actId="20577"/>
        <pc:sldMkLst>
          <pc:docMk/>
          <pc:sldMk cId="2719727650" sldId="256"/>
        </pc:sldMkLst>
        <pc:spChg chg="mod">
          <ac:chgData name="Alexandre" userId="2b2fb5af-1a8e-42b9-9a1c-9724d1b34ce9" providerId="ADAL" clId="{58E1968D-70AC-49E0-B4C2-774E1010BA66}" dt="2022-01-10T02:09:45.425" v="650" actId="20577"/>
          <ac:spMkLst>
            <pc:docMk/>
            <pc:sldMk cId="2719727650" sldId="256"/>
            <ac:spMk id="7" creationId="{543C05A5-DBBA-4D90-B4B9-D7723E71830F}"/>
          </ac:spMkLst>
        </pc:spChg>
        <pc:spChg chg="mod">
          <ac:chgData name="Alexandre" userId="2b2fb5af-1a8e-42b9-9a1c-9724d1b34ce9" providerId="ADAL" clId="{58E1968D-70AC-49E0-B4C2-774E1010BA66}" dt="2022-01-10T01:58:05.348" v="116" actId="1035"/>
          <ac:spMkLst>
            <pc:docMk/>
            <pc:sldMk cId="2719727650" sldId="256"/>
            <ac:spMk id="8" creationId="{32834ACB-938C-4FB5-8B02-3463646A3D32}"/>
          </ac:spMkLst>
        </pc:spChg>
        <pc:spChg chg="mod">
          <ac:chgData name="Alexandre" userId="2b2fb5af-1a8e-42b9-9a1c-9724d1b34ce9" providerId="ADAL" clId="{58E1968D-70AC-49E0-B4C2-774E1010BA66}" dt="2022-01-10T01:57:41.196" v="87" actId="1036"/>
          <ac:spMkLst>
            <pc:docMk/>
            <pc:sldMk cId="2719727650" sldId="256"/>
            <ac:spMk id="9" creationId="{088F1FFA-4DE3-4D34-AA38-AD064D98591A}"/>
          </ac:spMkLst>
        </pc:spChg>
        <pc:spChg chg="add mod">
          <ac:chgData name="Alexandre" userId="2b2fb5af-1a8e-42b9-9a1c-9724d1b34ce9" providerId="ADAL" clId="{58E1968D-70AC-49E0-B4C2-774E1010BA66}" dt="2022-01-10T01:58:13.327" v="117" actId="164"/>
          <ac:spMkLst>
            <pc:docMk/>
            <pc:sldMk cId="2719727650" sldId="256"/>
            <ac:spMk id="11" creationId="{BEA99672-AC32-4FD3-9A8D-2498BAE1217C}"/>
          </ac:spMkLst>
        </pc:spChg>
        <pc:grpChg chg="mod">
          <ac:chgData name="Alexandre" userId="2b2fb5af-1a8e-42b9-9a1c-9724d1b34ce9" providerId="ADAL" clId="{58E1968D-70AC-49E0-B4C2-774E1010BA66}" dt="2022-01-10T01:58:13.327" v="117" actId="164"/>
          <ac:grpSpMkLst>
            <pc:docMk/>
            <pc:sldMk cId="2719727650" sldId="256"/>
            <ac:grpSpMk id="10" creationId="{82AA0758-04B9-4B27-8868-85C9857DB1A7}"/>
          </ac:grpSpMkLst>
        </pc:grpChg>
        <pc:grpChg chg="add mod">
          <ac:chgData name="Alexandre" userId="2b2fb5af-1a8e-42b9-9a1c-9724d1b34ce9" providerId="ADAL" clId="{58E1968D-70AC-49E0-B4C2-774E1010BA66}" dt="2022-01-10T01:58:13.327" v="117" actId="164"/>
          <ac:grpSpMkLst>
            <pc:docMk/>
            <pc:sldMk cId="2719727650" sldId="256"/>
            <ac:grpSpMk id="13" creationId="{0FB5DD80-2DC9-44A6-A624-A8793B7BE6E3}"/>
          </ac:grpSpMkLst>
        </pc:grpChg>
        <pc:graphicFrameChg chg="add del mod">
          <ac:chgData name="Alexandre" userId="2b2fb5af-1a8e-42b9-9a1c-9724d1b34ce9" providerId="ADAL" clId="{58E1968D-70AC-49E0-B4C2-774E1010BA66}" dt="2022-01-10T01:44:28.857" v="6" actId="478"/>
          <ac:graphicFrameMkLst>
            <pc:docMk/>
            <pc:sldMk cId="2719727650" sldId="256"/>
            <ac:graphicFrameMk id="2" creationId="{201ADC1A-F7EA-4A25-A769-0C6D11F5A18C}"/>
          </ac:graphicFrameMkLst>
        </pc:graphicFrameChg>
        <pc:graphicFrameChg chg="add mod">
          <ac:chgData name="Alexandre" userId="2b2fb5af-1a8e-42b9-9a1c-9724d1b34ce9" providerId="ADAL" clId="{58E1968D-70AC-49E0-B4C2-774E1010BA66}" dt="2022-01-10T01:58:13.327" v="117" actId="164"/>
          <ac:graphicFrameMkLst>
            <pc:docMk/>
            <pc:sldMk cId="2719727650" sldId="256"/>
            <ac:graphicFrameMk id="3" creationId="{3954B51F-6714-412E-BE01-2F845D06661F}"/>
          </ac:graphicFrameMkLst>
        </pc:graphicFrameChg>
        <pc:graphicFrameChg chg="add mod">
          <ac:chgData name="Alexandre" userId="2b2fb5af-1a8e-42b9-9a1c-9724d1b34ce9" providerId="ADAL" clId="{58E1968D-70AC-49E0-B4C2-774E1010BA66}" dt="2022-01-10T01:58:13.327" v="117" actId="164"/>
          <ac:graphicFrameMkLst>
            <pc:docMk/>
            <pc:sldMk cId="2719727650" sldId="256"/>
            <ac:graphicFrameMk id="4" creationId="{F8462B7B-62EC-4051-BCCB-EE7AED9AB7AC}"/>
          </ac:graphicFrameMkLst>
        </pc:graphicFrameChg>
        <pc:graphicFrameChg chg="del">
          <ac:chgData name="Alexandre" userId="2b2fb5af-1a8e-42b9-9a1c-9724d1b34ce9" providerId="ADAL" clId="{58E1968D-70AC-49E0-B4C2-774E1010BA66}" dt="2022-01-10T01:38:14.610" v="0" actId="478"/>
          <ac:graphicFrameMkLst>
            <pc:docMk/>
            <pc:sldMk cId="2719727650" sldId="256"/>
            <ac:graphicFrameMk id="5" creationId="{103888DF-4F96-4BDD-B699-C35DE7982FC1}"/>
          </ac:graphicFrameMkLst>
        </pc:graphicFrameChg>
        <pc:graphicFrameChg chg="del">
          <ac:chgData name="Alexandre" userId="2b2fb5af-1a8e-42b9-9a1c-9724d1b34ce9" providerId="ADAL" clId="{58E1968D-70AC-49E0-B4C2-774E1010BA66}" dt="2022-01-10T01:38:18.060" v="1" actId="478"/>
          <ac:graphicFrameMkLst>
            <pc:docMk/>
            <pc:sldMk cId="2719727650" sldId="256"/>
            <ac:graphicFrameMk id="6" creationId="{2E4788A3-5024-413D-B836-DB57BB743B95}"/>
          </ac:graphicFrameMkLst>
        </pc:graphicFrameChg>
        <pc:graphicFrameChg chg="add mod ord">
          <ac:chgData name="Alexandre" userId="2b2fb5af-1a8e-42b9-9a1c-9724d1b34ce9" providerId="ADAL" clId="{58E1968D-70AC-49E0-B4C2-774E1010BA66}" dt="2022-01-10T01:58:13.327" v="117" actId="164"/>
          <ac:graphicFrameMkLst>
            <pc:docMk/>
            <pc:sldMk cId="2719727650" sldId="256"/>
            <ac:graphicFrameMk id="12" creationId="{F49B6B56-E60E-48B1-9B9C-39031D97DAB9}"/>
          </ac:graphicFrameMkLst>
        </pc:graphicFrameChg>
      </pc:sldChg>
    </pc:docChg>
  </pc:docChgLst>
  <pc:docChgLst>
    <pc:chgData name="Alexandre" userId="2b2fb5af-1a8e-42b9-9a1c-9724d1b34ce9" providerId="ADAL" clId="{04ACFD65-DE26-48B2-A4D1-0DD537DA7311}"/>
    <pc:docChg chg="undo custSel modSld">
      <pc:chgData name="Alexandre" userId="2b2fb5af-1a8e-42b9-9a1c-9724d1b34ce9" providerId="ADAL" clId="{04ACFD65-DE26-48B2-A4D1-0DD537DA7311}" dt="2022-01-10T01:36:39.853" v="1326" actId="164"/>
      <pc:docMkLst>
        <pc:docMk/>
      </pc:docMkLst>
      <pc:sldChg chg="addSp modSp mod">
        <pc:chgData name="Alexandre" userId="2b2fb5af-1a8e-42b9-9a1c-9724d1b34ce9" providerId="ADAL" clId="{04ACFD65-DE26-48B2-A4D1-0DD537DA7311}" dt="2022-01-10T01:36:39.853" v="1326" actId="164"/>
        <pc:sldMkLst>
          <pc:docMk/>
          <pc:sldMk cId="2719727650" sldId="256"/>
        </pc:sldMkLst>
        <pc:spChg chg="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7" creationId="{543C05A5-DBBA-4D90-B4B9-D7723E71830F}"/>
          </ac:spMkLst>
        </pc:spChg>
        <pc:spChg chg="add 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8" creationId="{32834ACB-938C-4FB5-8B02-3463646A3D32}"/>
          </ac:spMkLst>
        </pc:spChg>
        <pc:spChg chg="add 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9" creationId="{088F1FFA-4DE3-4D34-AA38-AD064D98591A}"/>
          </ac:spMkLst>
        </pc:spChg>
        <pc:grpChg chg="add mod">
          <ac:chgData name="Alexandre" userId="2b2fb5af-1a8e-42b9-9a1c-9724d1b34ce9" providerId="ADAL" clId="{04ACFD65-DE26-48B2-A4D1-0DD537DA7311}" dt="2022-01-10T01:36:39.853" v="1326" actId="164"/>
          <ac:grpSpMkLst>
            <pc:docMk/>
            <pc:sldMk cId="2719727650" sldId="256"/>
            <ac:grpSpMk id="10" creationId="{82AA0758-04B9-4B27-8868-85C9857DB1A7}"/>
          </ac:grpSpMkLst>
        </pc:grpChg>
        <pc:graphicFrameChg chg="mod">
          <ac:chgData name="Alexandre" userId="2b2fb5af-1a8e-42b9-9a1c-9724d1b34ce9" providerId="ADAL" clId="{04ACFD65-DE26-48B2-A4D1-0DD537DA7311}" dt="2022-01-10T01:36:39.853" v="1326" actId="164"/>
          <ac:graphicFrameMkLst>
            <pc:docMk/>
            <pc:sldMk cId="2719727650" sldId="256"/>
            <ac:graphicFrameMk id="5" creationId="{103888DF-4F96-4BDD-B699-C35DE7982FC1}"/>
          </ac:graphicFrameMkLst>
        </pc:graphicFrameChg>
        <pc:graphicFrameChg chg="mod">
          <ac:chgData name="Alexandre" userId="2b2fb5af-1a8e-42b9-9a1c-9724d1b34ce9" providerId="ADAL" clId="{04ACFD65-DE26-48B2-A4D1-0DD537DA7311}" dt="2022-01-10T01:36:39.853" v="1326" actId="164"/>
          <ac:graphicFrameMkLst>
            <pc:docMk/>
            <pc:sldMk cId="2719727650" sldId="256"/>
            <ac:graphicFrameMk id="6" creationId="{2E4788A3-5024-413D-B836-DB57BB743B95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872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420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572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617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88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251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6590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46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0372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77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282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335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0FB5DD80-2DC9-44A6-A624-A8793B7BE6E3}"/>
              </a:ext>
            </a:extLst>
          </p:cNvPr>
          <p:cNvGrpSpPr/>
          <p:nvPr/>
        </p:nvGrpSpPr>
        <p:grpSpPr>
          <a:xfrm>
            <a:off x="487745" y="464253"/>
            <a:ext cx="5787205" cy="8281735"/>
            <a:chOff x="487745" y="464253"/>
            <a:chExt cx="5787205" cy="8281735"/>
          </a:xfrm>
        </p:grpSpPr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F49B6B56-E60E-48B1-9B9C-39031D97DA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30061141"/>
                </p:ext>
              </p:extLst>
            </p:nvPr>
          </p:nvGraphicFramePr>
          <p:xfrm>
            <a:off x="583050" y="574177"/>
            <a:ext cx="5691900" cy="2992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9" r:id="rId3" imgW="8908149" imgH="4679861" progId="Prism9.Document">
                    <p:embed/>
                  </p:oleObj>
                </mc:Choice>
                <mc:Fallback>
                  <p:oleObj name="Prism 9" r:id="rId3" imgW="8908149" imgH="4679861" progId="Prism9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F49B6B56-E60E-48B1-9B9C-39031D97DAB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83050" y="574177"/>
                          <a:ext cx="5691900" cy="2992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2AA0758-04B9-4B27-8868-85C9857DB1A7}"/>
                </a:ext>
              </a:extLst>
            </p:cNvPr>
            <p:cNvGrpSpPr/>
            <p:nvPr/>
          </p:nvGrpSpPr>
          <p:grpSpPr>
            <a:xfrm>
              <a:off x="493568" y="464253"/>
              <a:ext cx="5781382" cy="8281735"/>
              <a:chOff x="493568" y="464253"/>
              <a:chExt cx="5781382" cy="8281735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43C05A5-DBBA-4D90-B4B9-D7723E71830F}"/>
                  </a:ext>
                </a:extLst>
              </p:cNvPr>
              <p:cNvSpPr txBox="1"/>
              <p:nvPr/>
            </p:nvSpPr>
            <p:spPr>
              <a:xfrm>
                <a:off x="583050" y="7914991"/>
                <a:ext cx="569190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GB" sz="800" b="1" dirty="0"/>
                  <a:t>Supplementary Figure S4. Impact of RNAi targeted against individual HHL signalling genes on the resistance of adult </a:t>
                </a:r>
                <a:r>
                  <a:rPr lang="en-GB" sz="800" b="1" i="1" dirty="0"/>
                  <a:t>C. elegans </a:t>
                </a:r>
                <a:r>
                  <a:rPr lang="en-GB" sz="800" b="1" dirty="0"/>
                  <a:t>to infection by </a:t>
                </a:r>
                <a:r>
                  <a:rPr lang="en-GB" sz="800" b="1" i="1" dirty="0"/>
                  <a:t>E. faecalis </a:t>
                </a:r>
                <a:r>
                  <a:rPr lang="en-GB" sz="800" b="1" dirty="0"/>
                  <a:t>OG1RF, </a:t>
                </a:r>
                <a:r>
                  <a:rPr lang="en-GB" sz="800" b="1" i="1" dirty="0"/>
                  <a:t>S. aureus</a:t>
                </a:r>
                <a:r>
                  <a:rPr lang="en-GB" sz="800" b="1" dirty="0"/>
                  <a:t>, and </a:t>
                </a:r>
                <a:r>
                  <a:rPr lang="en-GB" sz="800" b="1" i="1" dirty="0"/>
                  <a:t>P. aeruginosa </a:t>
                </a:r>
                <a:r>
                  <a:rPr lang="en-GB" sz="800" b="1" dirty="0"/>
                  <a:t>PA14. (A) </a:t>
                </a:r>
                <a:r>
                  <a:rPr lang="en-GB" sz="800" dirty="0"/>
                  <a:t>Resistance to </a:t>
                </a:r>
                <a:r>
                  <a:rPr lang="en-GB" sz="800" i="1" dirty="0"/>
                  <a:t>E. faecalis</a:t>
                </a:r>
                <a:r>
                  <a:rPr lang="en-GB" sz="800" dirty="0"/>
                  <a:t>. </a:t>
                </a:r>
                <a:r>
                  <a:rPr lang="en-GB" sz="800" b="1" dirty="0"/>
                  <a:t>(B) </a:t>
                </a:r>
                <a:r>
                  <a:rPr lang="en-GB" sz="800" dirty="0"/>
                  <a:t>Resistance to </a:t>
                </a:r>
                <a:r>
                  <a:rPr lang="en-GB" sz="800" i="1" dirty="0"/>
                  <a:t>S. aureus</a:t>
                </a:r>
                <a:r>
                  <a:rPr lang="en-GB" sz="800" dirty="0"/>
                  <a:t>. </a:t>
                </a:r>
                <a:r>
                  <a:rPr lang="en-GB" sz="800" b="1" dirty="0"/>
                  <a:t>(C) </a:t>
                </a:r>
                <a:r>
                  <a:rPr lang="en-GB" sz="800" dirty="0"/>
                  <a:t>Resistance to </a:t>
                </a:r>
                <a:r>
                  <a:rPr lang="en-GB" sz="800" i="1" dirty="0"/>
                  <a:t>P. aeruginosa</a:t>
                </a:r>
                <a:r>
                  <a:rPr lang="en-GB" sz="800" dirty="0"/>
                  <a:t>. 2-way ANOVA revealed a significant effect of RNAi, pathogen identity and their interaction on survival time (p&lt;0.001).  In particular individual RNAi differentially affected resistance to different pathogens. Pearson analyses found no correlations between the RNAi-associated resistance to either pathogen. Data were acquired for 2 to 4 biological replicates per condition using LFASS assays (Benedetto et al. 2019).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2834ACB-938C-4FB5-8B02-3463646A3D32}"/>
                  </a:ext>
                </a:extLst>
              </p:cNvPr>
              <p:cNvSpPr txBox="1"/>
              <p:nvPr/>
            </p:nvSpPr>
            <p:spPr>
              <a:xfrm>
                <a:off x="493568" y="464253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(A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88F1FFA-4DE3-4D34-AA38-AD064D98591A}"/>
                  </a:ext>
                </a:extLst>
              </p:cNvPr>
              <p:cNvSpPr txBox="1"/>
              <p:nvPr/>
            </p:nvSpPr>
            <p:spPr>
              <a:xfrm>
                <a:off x="493568" y="3323898"/>
                <a:ext cx="3674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/>
                  <a:t>(B)</a:t>
                </a:r>
              </a:p>
            </p:txBody>
          </p:sp>
        </p:grpSp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3954B51F-6714-412E-BE01-2F845D06661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49455657"/>
                </p:ext>
              </p:extLst>
            </p:nvPr>
          </p:nvGraphicFramePr>
          <p:xfrm>
            <a:off x="583050" y="5898941"/>
            <a:ext cx="5691900" cy="207319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5" imgW="8908149" imgH="3239655" progId="Prism9.Document">
                    <p:embed/>
                  </p:oleObj>
                </mc:Choice>
                <mc:Fallback>
                  <p:oleObj name="Prism 9" r:id="rId5" imgW="8908149" imgH="3239655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3954B51F-6714-412E-BE01-2F845D06661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83050" y="5898941"/>
                          <a:ext cx="5691900" cy="207319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EA99672-AC32-4FD3-9A8D-2498BAE1217C}"/>
                </a:ext>
              </a:extLst>
            </p:cNvPr>
            <p:cNvSpPr txBox="1"/>
            <p:nvPr/>
          </p:nvSpPr>
          <p:spPr>
            <a:xfrm>
              <a:off x="487745" y="5735550"/>
              <a:ext cx="367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(C)</a:t>
              </a:r>
            </a:p>
          </p:txBody>
        </p:sp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F8462B7B-62EC-4051-BCCB-EE7AED9AB7A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8201646"/>
                </p:ext>
              </p:extLst>
            </p:nvPr>
          </p:nvGraphicFramePr>
          <p:xfrm>
            <a:off x="583050" y="3321353"/>
            <a:ext cx="5691900" cy="276294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9" r:id="rId7" imgW="8908149" imgH="4318460" progId="Prism9.Document">
                    <p:embed/>
                  </p:oleObj>
                </mc:Choice>
                <mc:Fallback>
                  <p:oleObj name="Prism 9" r:id="rId7" imgW="8908149" imgH="4318460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F8462B7B-62EC-4051-BCCB-EE7AED9AB7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83050" y="3321353"/>
                          <a:ext cx="5691900" cy="276294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71972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3811305467C74494CB40DB3D5262DA" ma:contentTypeVersion="8" ma:contentTypeDescription="Create a new document." ma:contentTypeScope="" ma:versionID="8fc5784638860716a3723dffd2d08673">
  <xsd:schema xmlns:xsd="http://www.w3.org/2001/XMLSchema" xmlns:xs="http://www.w3.org/2001/XMLSchema" xmlns:p="http://schemas.microsoft.com/office/2006/metadata/properties" xmlns:ns2="c0db18e3-4c06-4c9d-ab15-91da0ad61027" targetNamespace="http://schemas.microsoft.com/office/2006/metadata/properties" ma:root="true" ma:fieldsID="e03991102f04ff9dcf3a5d4219758345" ns2:_="">
    <xsd:import namespace="c0db18e3-4c06-4c9d-ab15-91da0ad61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db18e3-4c06-4c9d-ab15-91da0ad610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34FA519-F248-4864-BD52-B6AA980F096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0db18e3-4c06-4c9d-ab15-91da0ad610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7706C2E-CB77-4E41-831B-AFD187929F11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A1D50951-B566-4B6F-A2BA-6D62605D120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142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e Benedetto</dc:creator>
  <cp:lastModifiedBy>Alejandra Zarate</cp:lastModifiedBy>
  <cp:revision>2</cp:revision>
  <dcterms:created xsi:type="dcterms:W3CDTF">2022-01-10T01:07:21Z</dcterms:created>
  <dcterms:modified xsi:type="dcterms:W3CDTF">2022-02-28T10:4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3811305467C74494CB40DB3D5262DA</vt:lpwstr>
  </property>
</Properties>
</file>